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93" r:id="rId2"/>
  </p:sldIdLst>
  <p:sldSz cx="15562263" cy="17546638"/>
  <p:notesSz cx="6858000" cy="9144000"/>
  <p:defaultTextStyle>
    <a:defPPr>
      <a:defRPr lang="en-US"/>
    </a:defPPr>
    <a:lvl1pPr marL="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2194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  <a:srgbClr val="000000"/>
    <a:srgbClr val="FFFFFF"/>
    <a:srgbClr val="FF40FF"/>
    <a:srgbClr val="AC27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30DB0B0-4C95-BE44-B672-672CD161B5D5}" v="3" dt="2024-08-15T20:43:42.99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19"/>
    <p:restoredTop sz="95714"/>
  </p:normalViewPr>
  <p:slideViewPr>
    <p:cSldViewPr snapToGrid="0">
      <p:cViewPr>
        <p:scale>
          <a:sx n="126" d="100"/>
          <a:sy n="126" d="100"/>
        </p:scale>
        <p:origin x="-1024" y="-85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1" d="2"/>
          <a:sy n="1" d="2"/>
        </p:scale>
        <p:origin x="0" y="0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5/10/relationships/revisionInfo" Target="revisionInfo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2B1137E9-3125-C9DC-069E-2EFC7FD4E75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8E7326-5A68-8CF5-B93F-4FAFF79AC1E2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B62AE7-0510-7043-8514-23341998D747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3C3C2B-31C4-A7B8-7F9A-4B2F8EF1A33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1B5F93-70EB-5C72-5813-7DFAB1A2F89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5B7DB3-4B09-6441-9E1D-2E54A81E2A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85590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525ECA-95A8-D54D-A55C-966C5ABDC60E}" type="datetimeFigureOut">
              <a:rPr lang="en-US" smtClean="0"/>
              <a:t>8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60575" y="1143000"/>
            <a:ext cx="2736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202569-D9CA-7442-9875-62C29A14AB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863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1pPr>
    <a:lvl2pPr marL="557190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2pPr>
    <a:lvl3pPr marL="111437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3pPr>
    <a:lvl4pPr marL="167156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4pPr>
    <a:lvl5pPr marL="2228759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5pPr>
    <a:lvl6pPr marL="278594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6pPr>
    <a:lvl7pPr marL="3343138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7pPr>
    <a:lvl8pPr marL="390032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8pPr>
    <a:lvl9pPr marL="4457517" algn="l" defTabSz="1114379" rtl="0" eaLnBrk="1" latinLnBrk="0" hangingPunct="1">
      <a:defRPr sz="146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1143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202569-D9CA-7442-9875-62C29A14AB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8065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139EB-7257-7444-846C-A830F519A4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945286" y="2871639"/>
            <a:ext cx="11671697" cy="6108831"/>
          </a:xfrm>
        </p:spPr>
        <p:txBody>
          <a:bodyPr anchor="b">
            <a:normAutofit/>
          </a:bodyPr>
          <a:lstStyle>
            <a:lvl1pPr algn="ctr">
              <a:defRPr sz="4679"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1FF011D-5936-024D-894E-5D7272C02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945286" y="9216051"/>
            <a:ext cx="11671697" cy="4236375"/>
          </a:xfrm>
        </p:spPr>
        <p:txBody>
          <a:bodyPr/>
          <a:lstStyle>
            <a:lvl1pPr marL="0" indent="0" algn="ctr">
              <a:buNone/>
              <a:defRPr sz="2808">
                <a:latin typeface="Helvetica" pitchFamily="2" charset="0"/>
                <a:cs typeface="Arial" panose="020B0604020202020204" pitchFamily="34" charset="0"/>
              </a:defRPr>
            </a:lvl1pPr>
            <a:lvl2pPr marL="534800" indent="0" algn="ctr">
              <a:buNone/>
              <a:defRPr sz="2339"/>
            </a:lvl2pPr>
            <a:lvl3pPr marL="1069601" indent="0" algn="ctr">
              <a:buNone/>
              <a:defRPr sz="2105"/>
            </a:lvl3pPr>
            <a:lvl4pPr marL="1604400" indent="0" algn="ctr">
              <a:buNone/>
              <a:defRPr sz="1871"/>
            </a:lvl4pPr>
            <a:lvl5pPr marL="2139200" indent="0" algn="ctr">
              <a:buNone/>
              <a:defRPr sz="1871"/>
            </a:lvl5pPr>
            <a:lvl6pPr marL="2674001" indent="0" algn="ctr">
              <a:buNone/>
              <a:defRPr sz="1871"/>
            </a:lvl6pPr>
            <a:lvl7pPr marL="3208801" indent="0" algn="ctr">
              <a:buNone/>
              <a:defRPr sz="1871"/>
            </a:lvl7pPr>
            <a:lvl8pPr marL="3743601" indent="0" algn="ctr">
              <a:buNone/>
              <a:defRPr sz="1871"/>
            </a:lvl8pPr>
            <a:lvl9pPr marL="4278401" indent="0" algn="ctr">
              <a:buNone/>
              <a:defRPr sz="1871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C64D72-5071-ED4A-AF12-75657B750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1C9DEA9D-5532-1949-9D14-26A30D988B6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B047D9-31F9-BC40-AB2B-EC56AF8F8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6870F0-923B-0543-854F-D39BA67620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8817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7044D-B51F-4546-8184-768D6ADE8E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D0F9904-7979-7F43-95DE-C5378709E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9F89EC-86B5-C74C-AABB-DC2621934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91DBA4-200E-9843-B255-CEC4C6AAC196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863029-53B8-844B-B239-06CD1560A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7F18CD-F8BD-C44A-8597-C2DB47E4D2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14215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8C94FF-AADF-BF41-A28C-B3390397EB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11136743" y="934196"/>
            <a:ext cx="3355614" cy="148699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FF3FEE-5F40-F248-B556-E00AA42CA1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1069908" y="934196"/>
            <a:ext cx="9872310" cy="148699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DF995-7FA5-864D-AF3F-7D6AB7AE2D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AFD97-F89F-A042-BCAC-BC0C1F5BBEE5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0E0DB7-A73C-F146-A650-8078BA459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75EA6-BF6F-744E-9873-479596026F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523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6BCAB-63B0-0B40-A1CD-6F636AE3D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73C1FF-5975-A24B-9612-9F4D8078EF0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  <a:lvl2pPr>
              <a:defRPr>
                <a:latin typeface="Helvetica" pitchFamily="2" charset="0"/>
              </a:defRPr>
            </a:lvl2pPr>
            <a:lvl3pPr>
              <a:defRPr>
                <a:latin typeface="Helvetica" pitchFamily="2" charset="0"/>
              </a:defRPr>
            </a:lvl3pPr>
            <a:lvl4pPr>
              <a:defRPr>
                <a:latin typeface="Helvetica" pitchFamily="2" charset="0"/>
              </a:defRPr>
            </a:lvl4pPr>
            <a:lvl5pPr>
              <a:defRPr>
                <a:latin typeface="Helvetica" pitchFamily="2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27CDC7-9740-B040-983D-33DDDDE70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340408B7-D42E-4C40-89A4-53776FE370D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0FD91A-E71C-1D47-94FA-105097732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7963D9-D362-084E-A363-1035C73F6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Helvetica" pitchFamily="2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10555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4406A6-B130-8646-91CA-51BA70943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1801" y="4374479"/>
            <a:ext cx="13422452" cy="7298912"/>
          </a:xfrm>
        </p:spPr>
        <p:txBody>
          <a:bodyPr anchor="b"/>
          <a:lstStyle>
            <a:lvl1pPr>
              <a:defRPr sz="7018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107092-8299-0F4C-96A4-1F50B49D68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1801" y="11742440"/>
            <a:ext cx="13422452" cy="3838326"/>
          </a:xfrm>
        </p:spPr>
        <p:txBody>
          <a:bodyPr/>
          <a:lstStyle>
            <a:lvl1pPr marL="0" indent="0">
              <a:buNone/>
              <a:defRPr sz="2808">
                <a:solidFill>
                  <a:schemeClr val="tx1">
                    <a:tint val="75000"/>
                  </a:schemeClr>
                </a:solidFill>
              </a:defRPr>
            </a:lvl1pPr>
            <a:lvl2pPr marL="534800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2pPr>
            <a:lvl3pPr marL="1069601" indent="0">
              <a:buNone/>
              <a:defRPr sz="2105">
                <a:solidFill>
                  <a:schemeClr val="tx1">
                    <a:tint val="75000"/>
                  </a:schemeClr>
                </a:solidFill>
              </a:defRPr>
            </a:lvl3pPr>
            <a:lvl4pPr marL="16044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4pPr>
            <a:lvl5pPr marL="2139200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5pPr>
            <a:lvl6pPr marL="26740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6pPr>
            <a:lvl7pPr marL="32088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7pPr>
            <a:lvl8pPr marL="37436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8pPr>
            <a:lvl9pPr marL="4278401" indent="0">
              <a:buNone/>
              <a:defRPr sz="18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D234A5-3EA3-114F-9B8B-EB41ACD3C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5F1EB0-11AC-F446-8CA5-7341363638B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FDE48-88CC-6844-9818-67B67F5D15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82AAED-26E7-0944-8097-920E2AE2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8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E0AA4-ECB6-C649-A5FD-599CA1B4BE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2737DD4-21E9-A04D-8AAA-6FF372C4F1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1069908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AE2B60-9163-5C47-B9BE-BB764836CD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878397" y="3743284"/>
            <a:ext cx="6613962" cy="1206087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1A7DC1-0841-544D-8B31-7BAE4AD41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1080E-0CB5-2941-B48B-86F18F07B5FA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4660F6-B518-6B45-868E-407C95D4D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DDEB9-06EA-3740-BB27-3320884BE1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2189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F03E9-9489-B344-96BA-70C2254DB1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2" y="934198"/>
            <a:ext cx="13422452" cy="339153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8ED0287-7AFF-A84D-916C-B7822B3E60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71933" y="4301366"/>
            <a:ext cx="6583566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586489-A7CB-EE4F-8D4A-9A4C48846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1071933" y="6409396"/>
            <a:ext cx="6583566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6F99574-E31E-EF42-916F-6A9CC901AE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7878398" y="4301366"/>
            <a:ext cx="6615989" cy="2108032"/>
          </a:xfrm>
        </p:spPr>
        <p:txBody>
          <a:bodyPr anchor="b"/>
          <a:lstStyle>
            <a:lvl1pPr marL="0" indent="0">
              <a:buNone/>
              <a:defRPr sz="2808" b="1"/>
            </a:lvl1pPr>
            <a:lvl2pPr marL="534800" indent="0">
              <a:buNone/>
              <a:defRPr sz="2339" b="1"/>
            </a:lvl2pPr>
            <a:lvl3pPr marL="1069601" indent="0">
              <a:buNone/>
              <a:defRPr sz="2105" b="1"/>
            </a:lvl3pPr>
            <a:lvl4pPr marL="1604400" indent="0">
              <a:buNone/>
              <a:defRPr sz="1871" b="1"/>
            </a:lvl4pPr>
            <a:lvl5pPr marL="2139200" indent="0">
              <a:buNone/>
              <a:defRPr sz="1871" b="1"/>
            </a:lvl5pPr>
            <a:lvl6pPr marL="2674001" indent="0">
              <a:buNone/>
              <a:defRPr sz="1871" b="1"/>
            </a:lvl6pPr>
            <a:lvl7pPr marL="3208801" indent="0">
              <a:buNone/>
              <a:defRPr sz="1871" b="1"/>
            </a:lvl7pPr>
            <a:lvl8pPr marL="3743601" indent="0">
              <a:buNone/>
              <a:defRPr sz="1871" b="1"/>
            </a:lvl8pPr>
            <a:lvl9pPr marL="4278401" indent="0">
              <a:buNone/>
              <a:defRPr sz="18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353DB1-1C23-404C-9DE8-78219D7C78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7878398" y="6409396"/>
            <a:ext cx="6615989" cy="942725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B1BB78-2A66-9D4F-BFBB-BB7E1C9A5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55C91F-C901-C74E-B457-F7DD6456F136}" type="datetime1">
              <a:rPr lang="en-US" smtClean="0"/>
              <a:t>8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FFCAAF-9320-C347-9837-DA18EAECCE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93220E-C952-9842-ADE8-3451593D17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32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8BD052-973D-994F-AF52-2A4EF5FBDE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5FF58DD-8363-6A46-9A18-1A3A67A027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79D0AC-686B-8B49-B366-3C844C4036EB}" type="datetime1">
              <a:rPr lang="en-US" smtClean="0"/>
              <a:t>8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98FEACB-F9AE-8C44-97F6-7880243121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56A4EF-28C8-B843-B0C9-3D10255B9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90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3EE6B9-1BFB-B447-ADE2-74BAB0E6F8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5D6573-C21F-0840-BAEF-1FF2575D4505}" type="datetime1">
              <a:rPr lang="en-US" smtClean="0"/>
              <a:t>8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1C450CF-5F7E-5045-8B0A-4C0434E62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094176-5BE4-AD43-A449-C8199EE33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4298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C1379-D019-6643-B88B-FB65AC5F9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58BD4D-DDCA-534A-8E83-F635DBDD4E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>
              <a:defRPr sz="3743"/>
            </a:lvl1pPr>
            <a:lvl2pPr>
              <a:defRPr sz="3275"/>
            </a:lvl2pPr>
            <a:lvl3pPr>
              <a:defRPr sz="2808"/>
            </a:lvl3pPr>
            <a:lvl4pPr>
              <a:defRPr sz="2339"/>
            </a:lvl4pPr>
            <a:lvl5pPr>
              <a:defRPr sz="2339"/>
            </a:lvl5pPr>
            <a:lvl6pPr>
              <a:defRPr sz="2339"/>
            </a:lvl6pPr>
            <a:lvl7pPr>
              <a:defRPr sz="2339"/>
            </a:lvl7pPr>
            <a:lvl8pPr>
              <a:defRPr sz="2339"/>
            </a:lvl8pPr>
            <a:lvl9pPr>
              <a:defRPr sz="233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442C9D0-AF82-204E-8201-19343DD61D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5368A2-7186-E749-BB60-CB45376A4D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D7268-FD7C-C042-A400-6B8C34629FE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29BA04-E120-A946-B561-D46CCA017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CC79DB-2B92-7742-9F5E-538E7EE6CD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297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F1C82B-7C1B-8F43-8CBD-0D90B839A3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71935" y="1169776"/>
            <a:ext cx="5019235" cy="4094216"/>
          </a:xfrm>
        </p:spPr>
        <p:txBody>
          <a:bodyPr anchor="b"/>
          <a:lstStyle>
            <a:lvl1pPr>
              <a:defRPr sz="374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15C3E0-9E53-C34D-8BE5-403FD64408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615990" y="2526393"/>
            <a:ext cx="7878396" cy="12469487"/>
          </a:xfrm>
        </p:spPr>
        <p:txBody>
          <a:bodyPr/>
          <a:lstStyle>
            <a:lvl1pPr marL="0" indent="0">
              <a:buNone/>
              <a:defRPr sz="3743"/>
            </a:lvl1pPr>
            <a:lvl2pPr marL="534800" indent="0">
              <a:buNone/>
              <a:defRPr sz="3275"/>
            </a:lvl2pPr>
            <a:lvl3pPr marL="1069601" indent="0">
              <a:buNone/>
              <a:defRPr sz="2808"/>
            </a:lvl3pPr>
            <a:lvl4pPr marL="1604400" indent="0">
              <a:buNone/>
              <a:defRPr sz="2339"/>
            </a:lvl4pPr>
            <a:lvl5pPr marL="2139200" indent="0">
              <a:buNone/>
              <a:defRPr sz="2339"/>
            </a:lvl5pPr>
            <a:lvl6pPr marL="2674001" indent="0">
              <a:buNone/>
              <a:defRPr sz="2339"/>
            </a:lvl6pPr>
            <a:lvl7pPr marL="3208801" indent="0">
              <a:buNone/>
              <a:defRPr sz="2339"/>
            </a:lvl7pPr>
            <a:lvl8pPr marL="3743601" indent="0">
              <a:buNone/>
              <a:defRPr sz="2339"/>
            </a:lvl8pPr>
            <a:lvl9pPr marL="4278401" indent="0">
              <a:buNone/>
              <a:defRPr sz="2339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4C6D1B-B939-084A-AA38-F2265164BA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071935" y="5263995"/>
            <a:ext cx="5019235" cy="9752194"/>
          </a:xfrm>
        </p:spPr>
        <p:txBody>
          <a:bodyPr/>
          <a:lstStyle>
            <a:lvl1pPr marL="0" indent="0">
              <a:buNone/>
              <a:defRPr sz="1871"/>
            </a:lvl1pPr>
            <a:lvl2pPr marL="534800" indent="0">
              <a:buNone/>
              <a:defRPr sz="1638"/>
            </a:lvl2pPr>
            <a:lvl3pPr marL="1069601" indent="0">
              <a:buNone/>
              <a:defRPr sz="1404"/>
            </a:lvl3pPr>
            <a:lvl4pPr marL="1604400" indent="0">
              <a:buNone/>
              <a:defRPr sz="1170"/>
            </a:lvl4pPr>
            <a:lvl5pPr marL="2139200" indent="0">
              <a:buNone/>
              <a:defRPr sz="1170"/>
            </a:lvl5pPr>
            <a:lvl6pPr marL="2674001" indent="0">
              <a:buNone/>
              <a:defRPr sz="1170"/>
            </a:lvl6pPr>
            <a:lvl7pPr marL="3208801" indent="0">
              <a:buNone/>
              <a:defRPr sz="1170"/>
            </a:lvl7pPr>
            <a:lvl8pPr marL="3743601" indent="0">
              <a:buNone/>
              <a:defRPr sz="1170"/>
            </a:lvl8pPr>
            <a:lvl9pPr marL="4278401" indent="0">
              <a:buNone/>
              <a:defRPr sz="117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95EC78-0900-3A42-A704-5CF19E63CC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69D5A2-F22A-5741-B25B-A3DF52EE1886}" type="datetime1">
              <a:rPr lang="en-US" smtClean="0"/>
              <a:t>8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1E44BA-DA4D-FB45-BD8D-5126D010E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FA10B7-6203-F24D-9E0C-733A6B0C23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1104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A985200-F03E-DA4D-914D-EBD5272FA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69906" y="934198"/>
            <a:ext cx="13422452" cy="28090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27D6C5-F073-1E46-B343-DB812445F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069906" y="3743282"/>
            <a:ext cx="13422452" cy="12072087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4EB330-0B14-4A48-890E-1E18399472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1069908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232FD189-7F13-AC44-ADD0-90F8923151ED}" type="datetime1">
              <a:rPr lang="en-US" smtClean="0"/>
              <a:t>8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F21E18-00F1-0145-899C-ECF615AEA9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155000" y="16263137"/>
            <a:ext cx="5252264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FFE07-FCDD-3549-9A82-C340CF9F90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990849" y="16263137"/>
            <a:ext cx="3501510" cy="93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04">
                <a:solidFill>
                  <a:schemeClr val="tx1">
                    <a:tint val="75000"/>
                  </a:schemeClr>
                </a:solidFill>
                <a:latin typeface="Helvetica" pitchFamily="2" charset="0"/>
                <a:cs typeface="Arial" panose="020B0604020202020204" pitchFamily="34" charset="0"/>
              </a:defRPr>
            </a:lvl1pPr>
          </a:lstStyle>
          <a:p>
            <a:fld id="{CE44A9E8-6FDC-F24D-B37B-1656C98EFDF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72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1069601" rtl="0" eaLnBrk="1" latinLnBrk="0" hangingPunct="1">
        <a:lnSpc>
          <a:spcPct val="90000"/>
        </a:lnSpc>
        <a:spcBef>
          <a:spcPct val="0"/>
        </a:spcBef>
        <a:buNone/>
        <a:defRPr sz="3275" kern="1200">
          <a:solidFill>
            <a:schemeClr val="tx1"/>
          </a:solidFill>
          <a:latin typeface="Helvetica" pitchFamily="2" charset="0"/>
          <a:ea typeface="+mj-ea"/>
          <a:cs typeface="Arial" panose="020B0604020202020204" pitchFamily="34" charset="0"/>
        </a:defRPr>
      </a:lvl1pPr>
    </p:titleStyle>
    <p:bodyStyle>
      <a:lvl1pPr marL="267400" indent="-267400" algn="l" defTabSz="1069601" rtl="0" eaLnBrk="1" latinLnBrk="0" hangingPunct="1">
        <a:lnSpc>
          <a:spcPct val="90000"/>
        </a:lnSpc>
        <a:spcBef>
          <a:spcPts val="117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1pPr>
      <a:lvl2pPr marL="8022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2pPr>
      <a:lvl3pPr marL="13370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871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3pPr>
      <a:lvl4pPr marL="1871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638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4pPr>
      <a:lvl5pPr marL="24066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1404" kern="1200">
          <a:solidFill>
            <a:schemeClr val="tx1"/>
          </a:solidFill>
          <a:latin typeface="Helvetica" pitchFamily="2" charset="0"/>
          <a:ea typeface="+mn-ea"/>
          <a:cs typeface="Arial" panose="020B0604020202020204" pitchFamily="34" charset="0"/>
        </a:defRPr>
      </a:lvl5pPr>
      <a:lvl6pPr marL="2941400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4762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40110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545801" indent="-267400" algn="l" defTabSz="1069601" rtl="0" eaLnBrk="1" latinLnBrk="0" hangingPunct="1">
        <a:lnSpc>
          <a:spcPct val="90000"/>
        </a:lnSpc>
        <a:spcBef>
          <a:spcPts val="585"/>
        </a:spcBef>
        <a:buFont typeface="Arial" panose="020B0604020202020204" pitchFamily="34" charset="0"/>
        <a:buChar char="•"/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1pPr>
      <a:lvl2pPr marL="5348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2pPr>
      <a:lvl3pPr marL="1069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3pPr>
      <a:lvl4pPr marL="16044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4pPr>
      <a:lvl5pPr marL="2139200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5pPr>
      <a:lvl6pPr marL="26740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6pPr>
      <a:lvl7pPr marL="32088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7pPr>
      <a:lvl8pPr marL="37436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8pPr>
      <a:lvl9pPr marL="4278401" algn="l" defTabSz="1069601" rtl="0" eaLnBrk="1" latinLnBrk="0" hangingPunct="1">
        <a:defRPr sz="21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5F74B3-D458-EBB5-9A47-4958F4FE6F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4A9E8-6FDC-F24D-B37B-1656C98EFDFD}" type="slidenum"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pPr/>
              <a:t>1</a:t>
            </a:fld>
            <a:endParaRPr 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2">
            <a:extLst>
              <a:ext uri="{FF2B5EF4-FFF2-40B4-BE49-F238E27FC236}">
                <a16:creationId xmlns:a16="http://schemas.microsoft.com/office/drawing/2014/main" id="{2B5FF00E-CDF7-2633-03CB-A33FBE093D61}"/>
              </a:ext>
            </a:extLst>
          </p:cNvPr>
          <p:cNvSpPr txBox="1"/>
          <p:nvPr/>
        </p:nvSpPr>
        <p:spPr>
          <a:xfrm>
            <a:off x="0" y="349306"/>
            <a:ext cx="4347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5259A06-E51D-F074-9C21-F0C88B678F0F}"/>
              </a:ext>
            </a:extLst>
          </p:cNvPr>
          <p:cNvSpPr txBox="1"/>
          <p:nvPr/>
        </p:nvSpPr>
        <p:spPr>
          <a:xfrm>
            <a:off x="723045" y="16103521"/>
            <a:ext cx="14107886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. Secretory changes in macrophages after carboplatin exposure.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 detection via LEGENDplex analysis of THP-1 derived (left) and PBMC-derived (right) macrophages using A) Immune Response panel and B) TNF family panel after 48 hours of vehicle or carboplatin (275 </a:t>
            </a:r>
            <a:r>
              <a:rPr lang="el-GR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treatment, total concentrations (</a:t>
            </a:r>
            <a:r>
              <a:rPr lang="en-US" sz="1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mL). Unpaired t-test. Mean and SEM. *p&lt;0.05, no stars indicate ns.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35D3848-47E9-B65A-2470-41D57D2FFAFB}"/>
              </a:ext>
            </a:extLst>
          </p:cNvPr>
          <p:cNvSpPr txBox="1"/>
          <p:nvPr/>
        </p:nvSpPr>
        <p:spPr>
          <a:xfrm>
            <a:off x="2205712" y="343445"/>
            <a:ext cx="259077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P-1 Immune Pane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E37A9BE-B2B3-7041-D54E-663B09612FAA}"/>
              </a:ext>
            </a:extLst>
          </p:cNvPr>
          <p:cNvSpPr txBox="1"/>
          <p:nvPr/>
        </p:nvSpPr>
        <p:spPr>
          <a:xfrm>
            <a:off x="2444367" y="8137320"/>
            <a:ext cx="23521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P-1 TNF-Family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560C049F-FDEC-2D0B-CE8A-8F2E7E4FD9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76971" y="8531269"/>
            <a:ext cx="6649689" cy="733386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BA488ED-2162-ED92-073C-8719E5E6836C}"/>
              </a:ext>
            </a:extLst>
          </p:cNvPr>
          <p:cNvSpPr txBox="1"/>
          <p:nvPr/>
        </p:nvSpPr>
        <p:spPr>
          <a:xfrm>
            <a:off x="217367" y="8640145"/>
            <a:ext cx="42030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57190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1437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156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228759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78594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343138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90032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457517" algn="l" defTabSz="1114379" rtl="0" eaLnBrk="1" latinLnBrk="0" hangingPunct="1">
              <a:defRPr sz="219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95224884-E80C-C76C-7C19-F9C1720CFA5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81242" y="8504698"/>
            <a:ext cx="6649689" cy="7360434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C948505-8988-9054-8C5E-F4BCA95D9E10}"/>
              </a:ext>
            </a:extLst>
          </p:cNvPr>
          <p:cNvSpPr txBox="1"/>
          <p:nvPr/>
        </p:nvSpPr>
        <p:spPr>
          <a:xfrm>
            <a:off x="9983931" y="8091635"/>
            <a:ext cx="23681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 TNF-Family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7E03D6E-9B5A-B2FC-E3BC-918F819C43E0}"/>
              </a:ext>
            </a:extLst>
          </p:cNvPr>
          <p:cNvSpPr txBox="1"/>
          <p:nvPr/>
        </p:nvSpPr>
        <p:spPr>
          <a:xfrm>
            <a:off x="9983931" y="423573"/>
            <a:ext cx="26068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BMC Immune Panel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5936A5F-1CA6-9085-40CF-28F1B411B28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61128" y="836916"/>
            <a:ext cx="6361341" cy="696772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70FEE3D-3855-EFEE-1469-0CFAC0167E4D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8181242" y="836916"/>
            <a:ext cx="6364224" cy="69677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0051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3">
      <a:dk1>
        <a:srgbClr val="000000"/>
      </a:dk1>
      <a:lt1>
        <a:srgbClr val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600" dirty="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DenayLuis_Paper layout V1" id="{E285C894-8600-BE43-9C63-6DC2C64A29EE}" vid="{C2BEA0BC-9915-6141-982A-C72D398425BF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381</TotalTime>
  <Words>95</Words>
  <Application>Microsoft Macintosh PowerPoint</Application>
  <PresentationFormat>Custom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LISAs of polarized macrophage supernatants: TNF-α and IL-1β (M1)</dc:title>
  <dc:creator>Microsoft Office User</dc:creator>
  <cp:lastModifiedBy>Carrie House</cp:lastModifiedBy>
  <cp:revision>79</cp:revision>
  <dcterms:created xsi:type="dcterms:W3CDTF">2022-01-18T04:14:07Z</dcterms:created>
  <dcterms:modified xsi:type="dcterms:W3CDTF">2024-08-20T23:33:30Z</dcterms:modified>
</cp:coreProperties>
</file>